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306940-5C30-4F05-80CA-61E3321AEC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B0E4E8-8AFA-4658-99AA-165D4CF487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6FE66-ACE5-41EB-9248-9A03952BE6B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89E7AD-03FB-452A-AA0F-C553FA7490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2A4E80-8184-40CE-9070-3B066BA2AA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E3BB9-6C6F-4ADB-B548-A7E2D1DAEC6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2BE56-29BC-4EA5-9B93-525D39C8A2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B8C4AA-DB5C-4E47-B50E-11981874AD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8298B-D65F-4ED6-888B-236A4359C4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2499C0-2794-458F-ABE4-621029E00E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BC7967-CD5D-42B8-A5C8-49AD5DD7E5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9AD6F-C566-4CFD-B76C-79804FD4DC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03FE7E-9733-4241-B346-93C6F33A3F6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5080" y="2540160"/>
            <a:ext cx="5668920" cy="6975360"/>
            <a:chOff x="235080" y="2540160"/>
            <a:chExt cx="5668920" cy="697536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504720" y="2540160"/>
              <a:ext cx="5399280" cy="6975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235080" y="2540160"/>
              <a:ext cx="261720" cy="6975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4" name=""/>
          <p:cNvGrpSpPr/>
          <p:nvPr/>
        </p:nvGrpSpPr>
        <p:grpSpPr>
          <a:xfrm>
            <a:off x="5829480" y="2481120"/>
            <a:ext cx="1380960" cy="7082640"/>
            <a:chOff x="5829480" y="2481120"/>
            <a:chExt cx="1380960" cy="7082640"/>
          </a:xfrm>
        </p:grpSpPr>
        <p:sp>
          <p:nvSpPr>
            <p:cNvPr id="45" name=""/>
            <p:cNvSpPr/>
            <p:nvPr/>
          </p:nvSpPr>
          <p:spPr>
            <a:xfrm>
              <a:off x="5829480" y="24811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829480" y="25830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DHAR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5829480" y="26845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EF1G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829480" y="27860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EF1G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829480" y="28861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829480" y="29876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829480" y="30891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5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829480" y="31910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829480" y="32907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Z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829480" y="33926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3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829480" y="34941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829480" y="35956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829480" y="36957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T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829480" y="37972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Z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829480" y="38988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829480" y="40006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829480" y="41004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5829480" y="42022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TCHQD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829480" y="43038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829480" y="44053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DHAR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829480" y="45054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829480" y="46069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829480" y="47084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829480" y="48099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3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829480" y="49100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829480" y="50115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829480" y="51134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829480" y="52149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829480" y="53150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5829480" y="54165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829480" y="55180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829480" y="56196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829480" y="57196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829480" y="58212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829480" y="59230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829480" y="60246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829480" y="61246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Z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829480" y="62262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829480" y="63277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829480" y="64292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3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829480" y="65293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829480" y="66308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829480" y="67327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829480" y="68342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829480" y="69343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829480" y="70358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5829480" y="71373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829480" y="72388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829480" y="73389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Z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829480" y="74404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829480" y="75423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829480" y="76438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829480" y="77439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829480" y="784548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829480" y="79470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829480" y="80485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829480" y="81486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3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829480" y="82501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829480" y="83520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829480" y="84535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829480" y="855360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5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5829480" y="865512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5829480" y="87566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5829480" y="88581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5829480" y="89582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4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5829480" y="90597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5829480" y="91616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5829480" y="926316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U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5829480" y="9363240"/>
              <a:ext cx="1380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700" spc="-1" strike="noStrike">
                  <a:solidFill>
                    <a:srgbClr val="000000"/>
                  </a:solidFill>
                  <a:latin typeface="Arial"/>
                </a:rPr>
                <a:t>OsGSTF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4" name=""/>
          <p:cNvGrpSpPr/>
          <p:nvPr/>
        </p:nvGrpSpPr>
        <p:grpSpPr>
          <a:xfrm>
            <a:off x="457200" y="1213920"/>
            <a:ext cx="5486760" cy="1416240"/>
            <a:chOff x="457200" y="1213920"/>
            <a:chExt cx="5486760" cy="1416240"/>
          </a:xfrm>
        </p:grpSpPr>
        <p:sp>
          <p:nvSpPr>
            <p:cNvPr id="115" name=""/>
            <p:cNvSpPr/>
            <p:nvPr/>
          </p:nvSpPr>
          <p:spPr>
            <a:xfrm rot="16200000">
              <a:off x="25272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Roo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rot="16200000">
              <a:off x="35748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rot="16200000">
              <a:off x="46080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Y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rot="16200000">
              <a:off x="66852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rot="16200000">
              <a:off x="77184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rot="16200000">
              <a:off x="87516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rot="16200000">
              <a:off x="97992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rot="16200000">
              <a:off x="108288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rot="16200000">
              <a:off x="118620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rot="16200000">
              <a:off x="128952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rot="16200000">
              <a:off x="139428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rot="16200000">
              <a:off x="149724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rot="16200000">
              <a:off x="160056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rot="16200000">
              <a:off x="170532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rot="16200000">
              <a:off x="180864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tigm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rot="16200000">
              <a:off x="191160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Ovary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rot="16200000">
              <a:off x="201492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6200000">
              <a:off x="211968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IA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6200000">
              <a:off x="222264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BA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rot="16200000">
              <a:off x="209736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30min-Roo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rot="16200000">
              <a:off x="220212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Z-30min-Roo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rot="16200000">
              <a:off x="2279880" y="1971000"/>
              <a:ext cx="1117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120min-Roo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6200000">
              <a:off x="240840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Z-120min-Roo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rot="16200000">
              <a:off x="251316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30min-Lea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6200000">
              <a:off x="261648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Z-30min-Lea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rot="16200000">
              <a:off x="2694240" y="1971000"/>
              <a:ext cx="11174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120min-Lea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rot="16200000">
              <a:off x="282276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tZ-120min-Leaf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rot="16200000">
              <a:off x="292752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rot="16200000">
              <a:off x="303084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D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rot="16200000">
              <a:off x="313416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rot="16200000">
              <a:off x="323892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C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rot="16200000">
              <a:off x="334188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Azucen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rot="16200000">
              <a:off x="344520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ArS-Azucen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rot="16200000">
              <a:off x="354852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Bal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rot="16200000">
              <a:off x="3653280" y="1996200"/>
              <a:ext cx="10666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ArS-Bal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rot="16200000">
              <a:off x="362592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Nipponbare-3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rot="16200000">
              <a:off x="372924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FR13-Nipponbare-3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rot="16200000">
              <a:off x="383400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Nipponbare-4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rot="16200000">
              <a:off x="393732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FR13-Nipponbare-4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rot="16200000">
              <a:off x="404028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IAC165-2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rot="16200000">
              <a:off x="414504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H-IAC165-2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rot="16200000">
              <a:off x="424836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IAC165-4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rot="16200000">
              <a:off x="435168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H-IAC165-4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rot="16200000">
              <a:off x="445464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IAC165-11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rot="16200000">
              <a:off x="455940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H-IAC165-11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rot="16200000">
              <a:off x="466272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Nipponbare-2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rot="16200000">
              <a:off x="476568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H-Nipponbare-2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rot="16200000">
              <a:off x="487044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Nipponbare-4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 rot="16200000">
              <a:off x="497376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H-Nipponbare-4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rot="16200000">
              <a:off x="5032800" y="1821600"/>
              <a:ext cx="14158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Mock-Nipponbare-11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 rot="16200000">
              <a:off x="5180040" y="1866240"/>
              <a:ext cx="1326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H-Nipponbare-11dpi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rot="16200000">
              <a:off x="563760" y="2224800"/>
              <a:ext cx="6094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3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SAM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67" name=""/>
          <p:cNvGrpSpPr/>
          <p:nvPr/>
        </p:nvGrpSpPr>
        <p:grpSpPr>
          <a:xfrm>
            <a:off x="500040" y="1490760"/>
            <a:ext cx="5400720" cy="8043840"/>
            <a:chOff x="500040" y="1490760"/>
            <a:chExt cx="5400720" cy="8043840"/>
          </a:xfrm>
        </p:grpSpPr>
        <p:sp>
          <p:nvSpPr>
            <p:cNvPr id="168" name=""/>
            <p:cNvSpPr/>
            <p:nvPr/>
          </p:nvSpPr>
          <p:spPr>
            <a:xfrm>
              <a:off x="500040" y="1490760"/>
              <a:ext cx="1771560" cy="8043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271600" y="1490760"/>
              <a:ext cx="1133640" cy="8043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405240" y="1490760"/>
              <a:ext cx="838080" cy="8043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4243320" y="1490760"/>
              <a:ext cx="1657440" cy="8043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2" name=""/>
          <p:cNvGrpSpPr/>
          <p:nvPr/>
        </p:nvGrpSpPr>
        <p:grpSpPr>
          <a:xfrm>
            <a:off x="425520" y="9567720"/>
            <a:ext cx="1944720" cy="304560"/>
            <a:chOff x="425520" y="9567720"/>
            <a:chExt cx="1944720" cy="304560"/>
          </a:xfrm>
        </p:grpSpPr>
        <p:sp>
          <p:nvSpPr>
            <p:cNvPr id="173" name=""/>
            <p:cNvSpPr/>
            <p:nvPr/>
          </p:nvSpPr>
          <p:spPr>
            <a:xfrm>
              <a:off x="425520" y="9686880"/>
              <a:ext cx="549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5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1803240" y="9686880"/>
              <a:ext cx="5670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11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1141560" y="9686880"/>
              <a:ext cx="4870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8.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76" name="" descr=""/>
            <p:cNvPicPr/>
            <p:nvPr/>
          </p:nvPicPr>
          <p:blipFill>
            <a:blip r:embed="rId3"/>
            <a:srcRect l="2673" t="-216" r="70746" b="98137"/>
            <a:stretch/>
          </p:blipFill>
          <p:spPr>
            <a:xfrm>
              <a:off x="581040" y="9567720"/>
              <a:ext cx="1423800" cy="177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77" name=""/>
          <p:cNvSpPr/>
          <p:nvPr/>
        </p:nvSpPr>
        <p:spPr>
          <a:xfrm>
            <a:off x="695160" y="1276200"/>
            <a:ext cx="138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evelopme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143080" y="1276200"/>
            <a:ext cx="138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ormon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3133800" y="1276200"/>
            <a:ext cx="138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biotic stres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381560" y="1276200"/>
            <a:ext cx="138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iotic stres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66760" y="239040"/>
            <a:ext cx="63720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Additional file 13. Expression patterns of rice GST genes in various tissues/organs/developmental stages and environmental conditions (various hormone, abiotic stress, arsenate stress and abiotic stress treatments)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 Hierarchical clustering analysis of 71 GST genes represented on Affymetrix Rice Genome Array is shown. For clustering we used average log signal values for two/three biological replicates of each sample after normalization of the raw data. The color scale for log signal values is shown at the bottom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02T10:58:01Z</dcterms:created>
  <dc:creator>Mukesh</dc:creator>
  <dc:description/>
  <dc:language>en-US</dc:language>
  <cp:lastModifiedBy>Mukesh</cp:lastModifiedBy>
  <dcterms:modified xsi:type="dcterms:W3CDTF">2009-11-24T13:32:36Z</dcterms:modified>
  <cp:revision>21</cp:revision>
  <dc:subject/>
  <dc:title>Slide 1</dc:title>
</cp:coreProperties>
</file>